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P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ita%20Gon&#231;alves\Documents\Assimila&#231;&#227;o%20de%20azoto\Manuscript\graficos-AA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ita%20Gon&#231;alves\Documents\Assimila&#231;&#227;o%20de%20azoto\Manuscript\graficos-AAT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ita%20Gon&#231;alves\Documents\Assimila&#231;&#227;o%20de%20azoto\Manuscript\graficos-AAT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ita%20Gon&#231;alves\Documents\Assimila&#231;&#227;o%20de%20azoto\Manuscript\graficos-AAT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ita%20Gon&#231;alves\Documents\Assimila&#231;&#227;o%20de%20azoto\Manuscript\graficos-AAT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t-P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pt-PT" sz="1000"/>
              <a:t>QsAAP3-lik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pt-PT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1]AAP3-2'!$C$43</c:f>
              <c:strCache>
                <c:ptCount val="1"/>
                <c:pt idx="0">
                  <c:v>non-Myc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1]AAP3-2'!$C$46:$C$47</c:f>
                <c:numCache>
                  <c:formatCode>General</c:formatCode>
                  <c:ptCount val="2"/>
                  <c:pt idx="0">
                    <c:v>9.5072844085210325E-3</c:v>
                  </c:pt>
                  <c:pt idx="1">
                    <c:v>9.2478293695802871E-4</c:v>
                  </c:pt>
                </c:numCache>
              </c:numRef>
            </c:plus>
            <c:minus>
              <c:numRef>
                <c:f>'[1]AAP3-2'!$C$46:$C$47</c:f>
                <c:numCache>
                  <c:formatCode>General</c:formatCode>
                  <c:ptCount val="2"/>
                  <c:pt idx="0">
                    <c:v>9.5072844085210325E-3</c:v>
                  </c:pt>
                  <c:pt idx="1">
                    <c:v>9.2478293695802871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1]AAP3-2'!$B$44:$B$45</c:f>
              <c:strCache>
                <c:ptCount val="2"/>
                <c:pt idx="0">
                  <c:v>Roots</c:v>
                </c:pt>
                <c:pt idx="1">
                  <c:v>Leaves</c:v>
                </c:pt>
              </c:strCache>
            </c:strRef>
          </c:cat>
          <c:val>
            <c:numRef>
              <c:f>'[1]AAP3-2'!$C$44:$C$45</c:f>
              <c:numCache>
                <c:formatCode>General</c:formatCode>
                <c:ptCount val="2"/>
                <c:pt idx="0">
                  <c:v>4.2271044013828162E-2</c:v>
                </c:pt>
                <c:pt idx="1">
                  <c:v>2.4186354830752323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76F-46F2-B4EC-BA1EB8ED39B4}"/>
            </c:ext>
          </c:extLst>
        </c:ser>
        <c:ser>
          <c:idx val="1"/>
          <c:order val="1"/>
          <c:tx>
            <c:strRef>
              <c:f>'[1]AAP3-2'!$D$43</c:f>
              <c:strCache>
                <c:ptCount val="1"/>
                <c:pt idx="0">
                  <c:v>Myc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1]AAP3-2'!$D$46:$D$47</c:f>
                <c:numCache>
                  <c:formatCode>General</c:formatCode>
                  <c:ptCount val="2"/>
                  <c:pt idx="0">
                    <c:v>1.2329155800717487E-3</c:v>
                  </c:pt>
                  <c:pt idx="1">
                    <c:v>5.1231175185966025E-4</c:v>
                  </c:pt>
                </c:numCache>
              </c:numRef>
            </c:plus>
            <c:minus>
              <c:numRef>
                <c:f>'[1]AAP3-2'!$D$46:$D$47</c:f>
                <c:numCache>
                  <c:formatCode>General</c:formatCode>
                  <c:ptCount val="2"/>
                  <c:pt idx="0">
                    <c:v>1.2329155800717487E-3</c:v>
                  </c:pt>
                  <c:pt idx="1">
                    <c:v>5.1231175185966025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1]AAP3-2'!$B$44:$B$45</c:f>
              <c:strCache>
                <c:ptCount val="2"/>
                <c:pt idx="0">
                  <c:v>Roots</c:v>
                </c:pt>
                <c:pt idx="1">
                  <c:v>Leaves</c:v>
                </c:pt>
              </c:strCache>
            </c:strRef>
          </c:cat>
          <c:val>
            <c:numRef>
              <c:f>'[1]AAP3-2'!$D$44:$D$45</c:f>
              <c:numCache>
                <c:formatCode>General</c:formatCode>
                <c:ptCount val="2"/>
                <c:pt idx="0">
                  <c:v>4.5836741951726261E-2</c:v>
                </c:pt>
                <c:pt idx="1">
                  <c:v>3.467736185396071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76F-46F2-B4EC-BA1EB8ED39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5007496"/>
        <c:axId val="505009136"/>
      </c:barChart>
      <c:catAx>
        <c:axId val="5050074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505009136"/>
        <c:crosses val="autoZero"/>
        <c:auto val="1"/>
        <c:lblAlgn val="ctr"/>
        <c:lblOffset val="100"/>
        <c:noMultiLvlLbl val="0"/>
      </c:catAx>
      <c:valAx>
        <c:axId val="50500913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5050074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2574978127734033"/>
          <c:y val="0.86700829284637282"/>
          <c:w val="0.42072222222222216"/>
          <c:h val="7.812554680664916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pt-PT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PT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t-P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pt-PT" sz="1000"/>
              <a:t>QsAAP6-lik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pt-PT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[1]AAP1_final!$C$39</c:f>
              <c:strCache>
                <c:ptCount val="1"/>
                <c:pt idx="0">
                  <c:v>non-Myc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[1]AAP1_final!$C$42:$C$43</c:f>
                <c:numCache>
                  <c:formatCode>General</c:formatCode>
                  <c:ptCount val="2"/>
                  <c:pt idx="0">
                    <c:v>1.5420080293027767E-3</c:v>
                  </c:pt>
                  <c:pt idx="1">
                    <c:v>2.525389216736237E-2</c:v>
                  </c:pt>
                </c:numCache>
              </c:numRef>
            </c:plus>
            <c:minus>
              <c:numRef>
                <c:f>[1]AAP1_final!$C$42:$C$43</c:f>
                <c:numCache>
                  <c:formatCode>General</c:formatCode>
                  <c:ptCount val="2"/>
                  <c:pt idx="0">
                    <c:v>1.5420080293027767E-3</c:v>
                  </c:pt>
                  <c:pt idx="1">
                    <c:v>2.52538921673623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1]AAP1_final!$B$40:$B$41</c:f>
              <c:strCache>
                <c:ptCount val="2"/>
                <c:pt idx="0">
                  <c:v>Roots</c:v>
                </c:pt>
                <c:pt idx="1">
                  <c:v>Leaves</c:v>
                </c:pt>
              </c:strCache>
            </c:strRef>
          </c:cat>
          <c:val>
            <c:numRef>
              <c:f>[1]AAP1_final!$C$40:$C$41</c:f>
              <c:numCache>
                <c:formatCode>General</c:formatCode>
                <c:ptCount val="2"/>
                <c:pt idx="0">
                  <c:v>1.5569496434201269E-2</c:v>
                </c:pt>
                <c:pt idx="1">
                  <c:v>0.132425814003485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C50-498B-BA57-B1FAC93658E4}"/>
            </c:ext>
          </c:extLst>
        </c:ser>
        <c:ser>
          <c:idx val="1"/>
          <c:order val="1"/>
          <c:tx>
            <c:strRef>
              <c:f>[1]AAP1_final!$D$39</c:f>
              <c:strCache>
                <c:ptCount val="1"/>
                <c:pt idx="0">
                  <c:v>Myc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[1]AAP1_final!$D$42:$D$43</c:f>
                <c:numCache>
                  <c:formatCode>General</c:formatCode>
                  <c:ptCount val="2"/>
                  <c:pt idx="0">
                    <c:v>4.8183194868208065E-3</c:v>
                  </c:pt>
                  <c:pt idx="1">
                    <c:v>4.7715444170429264E-2</c:v>
                  </c:pt>
                </c:numCache>
              </c:numRef>
            </c:plus>
            <c:minus>
              <c:numRef>
                <c:f>[1]AAP1_final!$D$42:$D$43</c:f>
                <c:numCache>
                  <c:formatCode>General</c:formatCode>
                  <c:ptCount val="2"/>
                  <c:pt idx="0">
                    <c:v>4.8183194868208065E-3</c:v>
                  </c:pt>
                  <c:pt idx="1">
                    <c:v>4.771544417042926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1]AAP1_final!$B$40:$B$41</c:f>
              <c:strCache>
                <c:ptCount val="2"/>
                <c:pt idx="0">
                  <c:v>Roots</c:v>
                </c:pt>
                <c:pt idx="1">
                  <c:v>Leaves</c:v>
                </c:pt>
              </c:strCache>
            </c:strRef>
          </c:cat>
          <c:val>
            <c:numRef>
              <c:f>[1]AAP1_final!$D$40:$D$41</c:f>
              <c:numCache>
                <c:formatCode>General</c:formatCode>
                <c:ptCount val="2"/>
                <c:pt idx="0">
                  <c:v>6.9592936526717596E-3</c:v>
                </c:pt>
                <c:pt idx="1">
                  <c:v>0.128481101274066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C50-498B-BA57-B1FAC93658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91966864"/>
        <c:axId val="591966208"/>
      </c:barChart>
      <c:catAx>
        <c:axId val="5919668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591966208"/>
        <c:crosses val="autoZero"/>
        <c:auto val="1"/>
        <c:lblAlgn val="ctr"/>
        <c:lblOffset val="100"/>
        <c:noMultiLvlLbl val="0"/>
      </c:catAx>
      <c:valAx>
        <c:axId val="59196620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5919668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0630533683289596"/>
          <c:y val="0.86604884845158425"/>
          <c:w val="0.38738888888888884"/>
          <c:h val="8.07421919150058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pt-PT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PT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t-P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pt-PT" sz="1000"/>
              <a:t>QsLHT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pt-PT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[1]LHT1_final!$C$39</c:f>
              <c:strCache>
                <c:ptCount val="1"/>
                <c:pt idx="0">
                  <c:v>non-Myc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[1]LHT1_final!$C$42:$C$43</c:f>
                <c:numCache>
                  <c:formatCode>General</c:formatCode>
                  <c:ptCount val="2"/>
                  <c:pt idx="0">
                    <c:v>7.0406038993567815E-2</c:v>
                  </c:pt>
                  <c:pt idx="1">
                    <c:v>0.41426694454100388</c:v>
                  </c:pt>
                </c:numCache>
              </c:numRef>
            </c:plus>
            <c:minus>
              <c:numRef>
                <c:f>[1]LHT1_final!$C$42:$C$43</c:f>
                <c:numCache>
                  <c:formatCode>General</c:formatCode>
                  <c:ptCount val="2"/>
                  <c:pt idx="0">
                    <c:v>7.0406038993567815E-2</c:v>
                  </c:pt>
                  <c:pt idx="1">
                    <c:v>0.414266944541003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1]LHT1_final!$B$40:$B$41</c:f>
              <c:strCache>
                <c:ptCount val="2"/>
                <c:pt idx="0">
                  <c:v>Roots</c:v>
                </c:pt>
                <c:pt idx="1">
                  <c:v>Leaves</c:v>
                </c:pt>
              </c:strCache>
            </c:strRef>
          </c:cat>
          <c:val>
            <c:numRef>
              <c:f>[1]LHT1_final!$C$40:$C$41</c:f>
              <c:numCache>
                <c:formatCode>General</c:formatCode>
                <c:ptCount val="2"/>
                <c:pt idx="0">
                  <c:v>0.60458330697438945</c:v>
                </c:pt>
                <c:pt idx="1">
                  <c:v>1.57076852002081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57E-4053-822A-C5E4222E8752}"/>
            </c:ext>
          </c:extLst>
        </c:ser>
        <c:ser>
          <c:idx val="1"/>
          <c:order val="1"/>
          <c:tx>
            <c:strRef>
              <c:f>[1]LHT1_final!$D$39</c:f>
              <c:strCache>
                <c:ptCount val="1"/>
                <c:pt idx="0">
                  <c:v>Myc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[1]LHT1_final!$D$42:$D$43</c:f>
                <c:numCache>
                  <c:formatCode>General</c:formatCode>
                  <c:ptCount val="2"/>
                  <c:pt idx="0">
                    <c:v>0.31381716509427232</c:v>
                  </c:pt>
                  <c:pt idx="1">
                    <c:v>0.48533198776732861</c:v>
                  </c:pt>
                </c:numCache>
              </c:numRef>
            </c:plus>
            <c:minus>
              <c:numRef>
                <c:f>[1]LHT1_final!$D$42:$D$43</c:f>
                <c:numCache>
                  <c:formatCode>General</c:formatCode>
                  <c:ptCount val="2"/>
                  <c:pt idx="0">
                    <c:v>0.31381716509427232</c:v>
                  </c:pt>
                  <c:pt idx="1">
                    <c:v>0.485331987767328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1]LHT1_final!$B$40:$B$41</c:f>
              <c:strCache>
                <c:ptCount val="2"/>
                <c:pt idx="0">
                  <c:v>Roots</c:v>
                </c:pt>
                <c:pt idx="1">
                  <c:v>Leaves</c:v>
                </c:pt>
              </c:strCache>
            </c:strRef>
          </c:cat>
          <c:val>
            <c:numRef>
              <c:f>[1]LHT1_final!$D$40:$D$41</c:f>
              <c:numCache>
                <c:formatCode>General</c:formatCode>
                <c:ptCount val="2"/>
                <c:pt idx="0">
                  <c:v>0.5280715797356299</c:v>
                </c:pt>
                <c:pt idx="1">
                  <c:v>1.05588872351153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57E-4053-822A-C5E4222E87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0273296"/>
        <c:axId val="550272968"/>
      </c:barChart>
      <c:catAx>
        <c:axId val="5502732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550272968"/>
        <c:crosses val="autoZero"/>
        <c:auto val="1"/>
        <c:lblAlgn val="ctr"/>
        <c:lblOffset val="100"/>
        <c:noMultiLvlLbl val="0"/>
      </c:catAx>
      <c:valAx>
        <c:axId val="55027296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5502732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6781686915174385"/>
          <c:y val="0.86630638796049775"/>
          <c:w val="0.49220581499334731"/>
          <c:h val="8.093581827451425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pt-PT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PT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t-P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pt-PT" sz="1000"/>
              <a:t>QsLHT1-lik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pt-PT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1]LHT1-like3 (final)'!$M$37</c:f>
              <c:strCache>
                <c:ptCount val="1"/>
                <c:pt idx="0">
                  <c:v>non-Myc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1]LHT1-like3 (final)'!$M$40:$M$41</c:f>
                <c:numCache>
                  <c:formatCode>General</c:formatCode>
                  <c:ptCount val="2"/>
                  <c:pt idx="0">
                    <c:v>8.9637530641955353E-5</c:v>
                  </c:pt>
                  <c:pt idx="1">
                    <c:v>3.7212429851868512E-5</c:v>
                  </c:pt>
                </c:numCache>
              </c:numRef>
            </c:plus>
            <c:minus>
              <c:numRef>
                <c:f>'[1]LHT1-like3 (final)'!$M$40:$M$41</c:f>
                <c:numCache>
                  <c:formatCode>General</c:formatCode>
                  <c:ptCount val="2"/>
                  <c:pt idx="0">
                    <c:v>8.9637530641955353E-5</c:v>
                  </c:pt>
                  <c:pt idx="1">
                    <c:v>3.7212429851868512E-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1]LHT1-like3 (final)'!$L$38:$L$39</c:f>
              <c:strCache>
                <c:ptCount val="2"/>
                <c:pt idx="0">
                  <c:v>Roots</c:v>
                </c:pt>
                <c:pt idx="1">
                  <c:v>Leaves</c:v>
                </c:pt>
              </c:strCache>
            </c:strRef>
          </c:cat>
          <c:val>
            <c:numRef>
              <c:f>'[1]LHT1-like3 (final)'!$M$38:$M$39</c:f>
              <c:numCache>
                <c:formatCode>General</c:formatCode>
                <c:ptCount val="2"/>
                <c:pt idx="0">
                  <c:v>4.2950010302522879E-4</c:v>
                </c:pt>
                <c:pt idx="1">
                  <c:v>5.257798310548986E-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1E7-41CF-AA71-08EA09846CBA}"/>
            </c:ext>
          </c:extLst>
        </c:ser>
        <c:ser>
          <c:idx val="1"/>
          <c:order val="1"/>
          <c:tx>
            <c:strRef>
              <c:f>'[1]LHT1-like3 (final)'!$N$37</c:f>
              <c:strCache>
                <c:ptCount val="1"/>
                <c:pt idx="0">
                  <c:v>Myc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1]LHT1-like3 (final)'!$N$40:$N$41</c:f>
                <c:numCache>
                  <c:formatCode>General</c:formatCode>
                  <c:ptCount val="2"/>
                  <c:pt idx="0">
                    <c:v>8.856398636701534E-5</c:v>
                  </c:pt>
                  <c:pt idx="1">
                    <c:v>3.5037975015029194E-5</c:v>
                  </c:pt>
                </c:numCache>
              </c:numRef>
            </c:plus>
            <c:minus>
              <c:numRef>
                <c:f>'[1]LHT1-like3 (final)'!$N$40:$N$41</c:f>
                <c:numCache>
                  <c:formatCode>General</c:formatCode>
                  <c:ptCount val="2"/>
                  <c:pt idx="0">
                    <c:v>8.856398636701534E-5</c:v>
                  </c:pt>
                  <c:pt idx="1">
                    <c:v>3.5037975015029194E-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1]LHT1-like3 (final)'!$L$38:$L$39</c:f>
              <c:strCache>
                <c:ptCount val="2"/>
                <c:pt idx="0">
                  <c:v>Roots</c:v>
                </c:pt>
                <c:pt idx="1">
                  <c:v>Leaves</c:v>
                </c:pt>
              </c:strCache>
            </c:strRef>
          </c:cat>
          <c:val>
            <c:numRef>
              <c:f>'[1]LHT1-like3 (final)'!$N$38:$N$39</c:f>
              <c:numCache>
                <c:formatCode>General</c:formatCode>
                <c:ptCount val="2"/>
                <c:pt idx="0">
                  <c:v>3.7592252626491955E-4</c:v>
                </c:pt>
                <c:pt idx="1">
                  <c:v>4.7218681843334439E-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1E7-41CF-AA71-08EA09846C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7826400"/>
        <c:axId val="557825744"/>
      </c:barChart>
      <c:catAx>
        <c:axId val="557826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557825744"/>
        <c:crosses val="autoZero"/>
        <c:auto val="1"/>
        <c:lblAlgn val="ctr"/>
        <c:lblOffset val="100"/>
        <c:noMultiLvlLbl val="0"/>
      </c:catAx>
      <c:valAx>
        <c:axId val="55782574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5578264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pt-PT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PT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t-P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pt-PT" sz="1000"/>
              <a:t>QsProT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pt-PT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[1]ProT2!$C$43</c:f>
              <c:strCache>
                <c:ptCount val="1"/>
                <c:pt idx="0">
                  <c:v>non-Myc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[1]ProT2!$C$46:$C$47</c:f>
                <c:numCache>
                  <c:formatCode>General</c:formatCode>
                  <c:ptCount val="2"/>
                  <c:pt idx="0">
                    <c:v>5.0696144717429488E-4</c:v>
                  </c:pt>
                  <c:pt idx="1">
                    <c:v>1.2708983501074045E-4</c:v>
                  </c:pt>
                </c:numCache>
              </c:numRef>
            </c:plus>
            <c:minus>
              <c:numRef>
                <c:f>[1]ProT2!$C$46:$C$47</c:f>
                <c:numCache>
                  <c:formatCode>General</c:formatCode>
                  <c:ptCount val="2"/>
                  <c:pt idx="0">
                    <c:v>5.0696144717429488E-4</c:v>
                  </c:pt>
                  <c:pt idx="1">
                    <c:v>1.2708983501074045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1]ProT2!$B$44:$B$45</c:f>
              <c:strCache>
                <c:ptCount val="2"/>
                <c:pt idx="0">
                  <c:v>Roots</c:v>
                </c:pt>
                <c:pt idx="1">
                  <c:v>Leaves</c:v>
                </c:pt>
              </c:strCache>
            </c:strRef>
          </c:cat>
          <c:val>
            <c:numRef>
              <c:f>[1]ProT2!$C$44:$C$45</c:f>
              <c:numCache>
                <c:formatCode>General</c:formatCode>
                <c:ptCount val="2"/>
                <c:pt idx="0">
                  <c:v>1.4418343661315592E-3</c:v>
                </c:pt>
                <c:pt idx="1">
                  <c:v>2.3186891675882593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ADA-4CC5-A7CD-FBC145255FAC}"/>
            </c:ext>
          </c:extLst>
        </c:ser>
        <c:ser>
          <c:idx val="1"/>
          <c:order val="1"/>
          <c:tx>
            <c:strRef>
              <c:f>[1]ProT2!$D$43</c:f>
              <c:strCache>
                <c:ptCount val="1"/>
                <c:pt idx="0">
                  <c:v>Myc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[1]ProT2!$D$46:$D$47</c:f>
                <c:numCache>
                  <c:formatCode>General</c:formatCode>
                  <c:ptCount val="2"/>
                  <c:pt idx="0">
                    <c:v>1.9202277984754334E-4</c:v>
                  </c:pt>
                  <c:pt idx="1">
                    <c:v>1.2478074895995176E-4</c:v>
                  </c:pt>
                </c:numCache>
              </c:numRef>
            </c:plus>
            <c:minus>
              <c:numRef>
                <c:f>[1]ProT2!$D$46:$D$47</c:f>
                <c:numCache>
                  <c:formatCode>General</c:formatCode>
                  <c:ptCount val="2"/>
                  <c:pt idx="0">
                    <c:v>1.9202277984754334E-4</c:v>
                  </c:pt>
                  <c:pt idx="1">
                    <c:v>1.2478074895995176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1]ProT2!$B$44:$B$45</c:f>
              <c:strCache>
                <c:ptCount val="2"/>
                <c:pt idx="0">
                  <c:v>Roots</c:v>
                </c:pt>
                <c:pt idx="1">
                  <c:v>Leaves</c:v>
                </c:pt>
              </c:strCache>
            </c:strRef>
          </c:cat>
          <c:val>
            <c:numRef>
              <c:f>[1]ProT2!$D$44:$D$45</c:f>
              <c:numCache>
                <c:formatCode>General</c:formatCode>
                <c:ptCount val="2"/>
                <c:pt idx="0">
                  <c:v>1.0160467693828129E-3</c:v>
                </c:pt>
                <c:pt idx="1">
                  <c:v>8.8233313751118138E-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ADA-4CC5-A7CD-FBC145255F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7950792"/>
        <c:axId val="507950136"/>
      </c:barChart>
      <c:catAx>
        <c:axId val="5079507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507950136"/>
        <c:crosses val="autoZero"/>
        <c:auto val="1"/>
        <c:lblAlgn val="ctr"/>
        <c:lblOffset val="100"/>
        <c:noMultiLvlLbl val="0"/>
      </c:catAx>
      <c:valAx>
        <c:axId val="50795013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50795079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pt-PT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P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05CCD79-F67E-4C93-9CC9-C60E6A00A9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814D8AD3-55D8-4B92-A6C3-3B3252C650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PT"/>
              <a:t>Clique para editar o estilo de subtítulo do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253F4EA3-2E96-4148-9FD0-D737E3F14B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FD6EA-B892-4C8A-826C-335E3FFE283A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018213D8-E5C1-4B9D-8E5D-B94CF4A5B2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022E7802-5127-410D-B62C-9B4222CD24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D8776-73E6-4DBD-A8F4-0E746A7520B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5836836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8932167-17C7-4255-BC42-4E3C811EB5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3162F52A-1ADF-439A-9840-20B5B3C485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978FE6D5-E83B-4A48-BDD1-B2E05592A0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FD6EA-B892-4C8A-826C-335E3FFE283A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99A605B1-622D-4C9D-BCE3-8E43CCE1D9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046520CF-9BD1-4429-B1E0-D7FD3F61F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D8776-73E6-4DBD-A8F4-0E746A7520B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552275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A65F5AA1-045D-46EE-B53A-760363331D2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DBCDB7DF-34E1-4DEA-AF45-BA50B687F8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43177A44-E04B-439B-A0E3-18E9D89D43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FD6EA-B892-4C8A-826C-335E3FFE283A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2828FF31-2EF0-4D79-982A-4F46C0C9CB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CF7DCE45-38D9-4CCC-A9EE-5F0D6CA184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D8776-73E6-4DBD-A8F4-0E746A7520B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8356469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26496E2-AC73-43D8-BA87-99A3C97334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F8447DA8-D54D-4129-B593-7C8494822AD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7DB90E40-0F01-4CA6-9BC9-B4BE1FB5B4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FD6EA-B892-4C8A-826C-335E3FFE283A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BEFF01FB-1AFF-4C01-A717-043DD1E3DC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C5860433-7B01-4BBD-A010-F054299C49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D8776-73E6-4DBD-A8F4-0E746A7520B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1387456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69E3334-BC79-4326-97FE-72B7898111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E37A5288-FCCF-4173-A173-30442324F5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CD77DE1F-55A8-4803-B15D-BF7764C5A1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FD6EA-B892-4C8A-826C-335E3FFE283A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A7430FE7-F068-4178-8E3A-AC5E8F2507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B49D5D5B-BB2F-4C81-BE6D-17666EC727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D8776-73E6-4DBD-A8F4-0E746A7520B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3505865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427628B-D6DA-40B6-B136-287A0EB23A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60B8BD9F-59DD-4BC3-8CE4-043388D65A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CC9FAC00-AD69-4A2C-8FE8-12359595AD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EBDB311D-28C9-4DD4-8193-E18C3C590A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FD6EA-B892-4C8A-826C-335E3FFE283A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31C8285A-F9D4-4217-B464-6BC4B1E26C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88B02825-1A4F-446C-8F96-FEF59225A5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D8776-73E6-4DBD-A8F4-0E746A7520B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0909159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B392DFE-AF6F-46EC-9DBD-1033D06FE2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0BDC42D2-7875-4898-A039-747FE189EF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6C2C9F77-4A0C-4FAD-BBAB-1F3E2B797C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o Texto 4">
            <a:extLst>
              <a:ext uri="{FF2B5EF4-FFF2-40B4-BE49-F238E27FC236}">
                <a16:creationId xmlns:a16="http://schemas.microsoft.com/office/drawing/2014/main" id="{A4499203-D599-4F00-9D10-453C7EFA802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Marcador de Posição de Conteúdo 5">
            <a:extLst>
              <a:ext uri="{FF2B5EF4-FFF2-40B4-BE49-F238E27FC236}">
                <a16:creationId xmlns:a16="http://schemas.microsoft.com/office/drawing/2014/main" id="{0110C3A3-A4AC-427D-99FE-2D9AA255CAB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7" name="Marcador de Posição da Data 6">
            <a:extLst>
              <a:ext uri="{FF2B5EF4-FFF2-40B4-BE49-F238E27FC236}">
                <a16:creationId xmlns:a16="http://schemas.microsoft.com/office/drawing/2014/main" id="{B7CAB9CC-7763-4382-8AA1-9746DDFC0F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FD6EA-B892-4C8A-826C-335E3FFE283A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8" name="Marcador de Posição do Rodapé 7">
            <a:extLst>
              <a:ext uri="{FF2B5EF4-FFF2-40B4-BE49-F238E27FC236}">
                <a16:creationId xmlns:a16="http://schemas.microsoft.com/office/drawing/2014/main" id="{987D188B-84B8-4399-9F56-5C903CDF6C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Marcador de Posição do Número do Diapositivo 8">
            <a:extLst>
              <a:ext uri="{FF2B5EF4-FFF2-40B4-BE49-F238E27FC236}">
                <a16:creationId xmlns:a16="http://schemas.microsoft.com/office/drawing/2014/main" id="{356791CD-DE83-4B5A-B0A3-2B69D31B8D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D8776-73E6-4DBD-A8F4-0E746A7520B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9678047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AB36F23-8AA8-4296-94D4-8DC3C0DE4C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a Data 2">
            <a:extLst>
              <a:ext uri="{FF2B5EF4-FFF2-40B4-BE49-F238E27FC236}">
                <a16:creationId xmlns:a16="http://schemas.microsoft.com/office/drawing/2014/main" id="{97CA47B1-9E56-4C79-B67D-84455E12C6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FD6EA-B892-4C8A-826C-335E3FFE283A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4" name="Marcador de Posição do Rodapé 3">
            <a:extLst>
              <a:ext uri="{FF2B5EF4-FFF2-40B4-BE49-F238E27FC236}">
                <a16:creationId xmlns:a16="http://schemas.microsoft.com/office/drawing/2014/main" id="{53F0F498-4756-4AC1-80A7-255DCD0CD2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Marcador de Posição do Número do Diapositivo 4">
            <a:extLst>
              <a:ext uri="{FF2B5EF4-FFF2-40B4-BE49-F238E27FC236}">
                <a16:creationId xmlns:a16="http://schemas.microsoft.com/office/drawing/2014/main" id="{720F0DDB-970C-423A-8A98-39330A9739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D8776-73E6-4DBD-A8F4-0E746A7520B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074164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>
            <a:extLst>
              <a:ext uri="{FF2B5EF4-FFF2-40B4-BE49-F238E27FC236}">
                <a16:creationId xmlns:a16="http://schemas.microsoft.com/office/drawing/2014/main" id="{5EB2D77B-35D4-4D03-871B-6AB19DB98D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FD6EA-B892-4C8A-826C-335E3FFE283A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3" name="Marcador de Posição do Rodapé 2">
            <a:extLst>
              <a:ext uri="{FF2B5EF4-FFF2-40B4-BE49-F238E27FC236}">
                <a16:creationId xmlns:a16="http://schemas.microsoft.com/office/drawing/2014/main" id="{220E5D25-49D0-4F91-823C-8A2EA84D4A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Marcador de Posição do Número do Diapositivo 3">
            <a:extLst>
              <a:ext uri="{FF2B5EF4-FFF2-40B4-BE49-F238E27FC236}">
                <a16:creationId xmlns:a16="http://schemas.microsoft.com/office/drawing/2014/main" id="{DF1783E7-A86E-4A09-8D83-077D5B373C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D8776-73E6-4DBD-A8F4-0E746A7520B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0336756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E4551AD-66B7-433D-AA0D-8688549C22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58C4797C-E358-4281-A7C1-C5737C7555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18382401-1E52-425B-826E-2B8FDB15DD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B009ADCA-3B2B-45FB-976D-6F3B01B1D1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FD6EA-B892-4C8A-826C-335E3FFE283A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066E865F-9B4A-4624-9CF0-DEBE8A4A1C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817FC93B-95E2-4061-A2C0-9ACA734583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D8776-73E6-4DBD-A8F4-0E746A7520B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674307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D58139F-850E-48DD-AB62-F327077B03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a Imagem 2">
            <a:extLst>
              <a:ext uri="{FF2B5EF4-FFF2-40B4-BE49-F238E27FC236}">
                <a16:creationId xmlns:a16="http://schemas.microsoft.com/office/drawing/2014/main" id="{C707A001-0D41-4EE6-BB3D-825A9C8532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PT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BE8B8066-28A5-46B5-B9C9-537D235493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249577BD-275C-4C6F-B8AA-24130A490E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FD6EA-B892-4C8A-826C-335E3FFE283A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77C520BA-3A55-46EF-AA2F-8C75EEAF27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F781FFE9-820A-4CE6-ABDD-65A71A280A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D8776-73E6-4DBD-A8F4-0E746A7520B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621397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>
            <a:extLst>
              <a:ext uri="{FF2B5EF4-FFF2-40B4-BE49-F238E27FC236}">
                <a16:creationId xmlns:a16="http://schemas.microsoft.com/office/drawing/2014/main" id="{0B1AD50B-4A9A-493D-AC66-4ACB1695E0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CC30D917-84E2-49E9-8115-0171095441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D63251BA-95BE-41F0-9B32-CA6778B601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9FD6EA-B892-4C8A-826C-335E3FFE283A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DC59CD34-F727-4261-833F-68106E6468F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635FAB4D-7CBB-4235-AD42-9EF7617E7B3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2D8776-73E6-4DBD-A8F4-0E746A7520B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9288442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Agrupar 8">
            <a:extLst>
              <a:ext uri="{FF2B5EF4-FFF2-40B4-BE49-F238E27FC236}">
                <a16:creationId xmlns:a16="http://schemas.microsoft.com/office/drawing/2014/main" id="{E9116E3F-B4BE-4265-B11B-D855862C158A}"/>
              </a:ext>
            </a:extLst>
          </p:cNvPr>
          <p:cNvGrpSpPr/>
          <p:nvPr/>
        </p:nvGrpSpPr>
        <p:grpSpPr>
          <a:xfrm>
            <a:off x="1139825" y="225425"/>
            <a:ext cx="7029450" cy="4879975"/>
            <a:chOff x="1139825" y="835025"/>
            <a:chExt cx="7029450" cy="4879975"/>
          </a:xfrm>
        </p:grpSpPr>
        <p:graphicFrame>
          <p:nvGraphicFramePr>
            <p:cNvPr id="4" name="Gráfico 3">
              <a:extLst>
                <a:ext uri="{FF2B5EF4-FFF2-40B4-BE49-F238E27FC236}">
                  <a16:creationId xmlns:a16="http://schemas.microsoft.com/office/drawing/2014/main" id="{532F037B-F1CC-4268-BBEC-B3D394B1C47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93381698"/>
                </p:ext>
              </p:extLst>
            </p:nvPr>
          </p:nvGraphicFramePr>
          <p:xfrm>
            <a:off x="1143000" y="835025"/>
            <a:ext cx="2286000" cy="2387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Gráfico 4">
              <a:extLst>
                <a:ext uri="{FF2B5EF4-FFF2-40B4-BE49-F238E27FC236}">
                  <a16:creationId xmlns:a16="http://schemas.microsoft.com/office/drawing/2014/main" id="{4B211642-A58C-4782-A997-EDCAFD38FB4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08759172"/>
                </p:ext>
              </p:extLst>
            </p:nvPr>
          </p:nvGraphicFramePr>
          <p:xfrm>
            <a:off x="3429000" y="835025"/>
            <a:ext cx="2286000" cy="2387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Gráfico 5">
              <a:extLst>
                <a:ext uri="{FF2B5EF4-FFF2-40B4-BE49-F238E27FC236}">
                  <a16:creationId xmlns:a16="http://schemas.microsoft.com/office/drawing/2014/main" id="{CD83D616-1FFF-433E-B50F-D73D0C12BC4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32579680"/>
                </p:ext>
              </p:extLst>
            </p:nvPr>
          </p:nvGraphicFramePr>
          <p:xfrm>
            <a:off x="1139825" y="3222625"/>
            <a:ext cx="2292350" cy="23939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7" name="Gráfico 6">
              <a:extLst>
                <a:ext uri="{FF2B5EF4-FFF2-40B4-BE49-F238E27FC236}">
                  <a16:creationId xmlns:a16="http://schemas.microsoft.com/office/drawing/2014/main" id="{63C99F39-577C-41A8-9802-29454A8CBDD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42391033"/>
                </p:ext>
              </p:extLst>
            </p:nvPr>
          </p:nvGraphicFramePr>
          <p:xfrm>
            <a:off x="3505200" y="3219450"/>
            <a:ext cx="2286000" cy="24003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8" name="Gráfico 7">
              <a:extLst>
                <a:ext uri="{FF2B5EF4-FFF2-40B4-BE49-F238E27FC236}">
                  <a16:creationId xmlns:a16="http://schemas.microsoft.com/office/drawing/2014/main" id="{B96FE4C0-23D6-4CE8-9D5D-3C631E4DF4A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34178330"/>
                </p:ext>
              </p:extLst>
            </p:nvPr>
          </p:nvGraphicFramePr>
          <p:xfrm>
            <a:off x="5864225" y="3314700"/>
            <a:ext cx="2305050" cy="24003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</p:grpSp>
      <p:sp>
        <p:nvSpPr>
          <p:cNvPr id="2" name="CaixaDeTexto 1">
            <a:extLst>
              <a:ext uri="{FF2B5EF4-FFF2-40B4-BE49-F238E27FC236}">
                <a16:creationId xmlns:a16="http://schemas.microsoft.com/office/drawing/2014/main" id="{D3B891DE-4E4E-43D3-8567-A6AC34AC75EA}"/>
              </a:ext>
            </a:extLst>
          </p:cNvPr>
          <p:cNvSpPr txBox="1"/>
          <p:nvPr/>
        </p:nvSpPr>
        <p:spPr>
          <a:xfrm>
            <a:off x="876299" y="5410200"/>
            <a:ext cx="911542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600" b="1" dirty="0"/>
              <a:t>Figure S1</a:t>
            </a:r>
            <a:r>
              <a:rPr lang="pt-PT" sz="1600" dirty="0"/>
              <a:t>- </a:t>
            </a:r>
            <a:r>
              <a:rPr lang="pt-PT" sz="1600" dirty="0" err="1"/>
              <a:t>Quantification</a:t>
            </a:r>
            <a:r>
              <a:rPr lang="pt-PT" sz="1600" dirty="0"/>
              <a:t> </a:t>
            </a:r>
            <a:r>
              <a:rPr lang="pt-PT" sz="1600" dirty="0" err="1"/>
              <a:t>by</a:t>
            </a:r>
            <a:r>
              <a:rPr lang="pt-PT" sz="1600" dirty="0"/>
              <a:t> </a:t>
            </a:r>
            <a:r>
              <a:rPr lang="pt-PT" sz="1600" dirty="0" err="1"/>
              <a:t>qPCR</a:t>
            </a:r>
            <a:r>
              <a:rPr lang="pt-PT" sz="1600" dirty="0"/>
              <a:t> </a:t>
            </a:r>
            <a:r>
              <a:rPr lang="pt-PT" sz="1600" dirty="0" err="1"/>
              <a:t>of</a:t>
            </a:r>
            <a:r>
              <a:rPr lang="pt-PT" sz="1600" dirty="0"/>
              <a:t> </a:t>
            </a:r>
            <a:r>
              <a:rPr lang="pt-PT" sz="1600" dirty="0" err="1"/>
              <a:t>amino</a:t>
            </a:r>
            <a:r>
              <a:rPr lang="pt-PT" sz="1600" dirty="0"/>
              <a:t> </a:t>
            </a:r>
            <a:r>
              <a:rPr lang="pt-PT" sz="1600" dirty="0" err="1"/>
              <a:t>acid</a:t>
            </a:r>
            <a:r>
              <a:rPr lang="pt-PT" sz="1600" dirty="0"/>
              <a:t> </a:t>
            </a:r>
            <a:r>
              <a:rPr lang="pt-PT" sz="1600" dirty="0" err="1"/>
              <a:t>transporters</a:t>
            </a:r>
            <a:r>
              <a:rPr lang="pt-PT" sz="1600" dirty="0"/>
              <a:t> gene </a:t>
            </a:r>
            <a:r>
              <a:rPr lang="pt-PT" sz="1600" dirty="0" err="1"/>
              <a:t>expression</a:t>
            </a:r>
            <a:r>
              <a:rPr lang="pt-PT" sz="1600" dirty="0"/>
              <a:t> in </a:t>
            </a:r>
            <a:r>
              <a:rPr lang="pt-PT" sz="1600" dirty="0" err="1"/>
              <a:t>roots</a:t>
            </a:r>
            <a:r>
              <a:rPr lang="pt-PT" sz="1600" dirty="0"/>
              <a:t> </a:t>
            </a:r>
            <a:r>
              <a:rPr lang="pt-PT" sz="1600" dirty="0" err="1"/>
              <a:t>and</a:t>
            </a:r>
            <a:r>
              <a:rPr lang="pt-PT" sz="1600" dirty="0"/>
              <a:t> </a:t>
            </a:r>
            <a:r>
              <a:rPr lang="pt-PT" sz="1600" dirty="0" err="1"/>
              <a:t>leaves</a:t>
            </a:r>
            <a:r>
              <a:rPr lang="pt-PT" sz="1600" dirty="0"/>
              <a:t> </a:t>
            </a:r>
            <a:r>
              <a:rPr lang="pt-PT" sz="1600" dirty="0" err="1"/>
              <a:t>of</a:t>
            </a:r>
            <a:r>
              <a:rPr lang="pt-PT" sz="1600" dirty="0"/>
              <a:t> P. </a:t>
            </a:r>
            <a:r>
              <a:rPr lang="pt-PT" sz="1600" dirty="0" err="1"/>
              <a:t>tinctorius</a:t>
            </a:r>
            <a:r>
              <a:rPr lang="pt-PT" sz="1600" dirty="0"/>
              <a:t> </a:t>
            </a:r>
            <a:r>
              <a:rPr lang="pt-PT" sz="1600" dirty="0" err="1"/>
              <a:t>mycorrhizal</a:t>
            </a:r>
            <a:r>
              <a:rPr lang="pt-PT" sz="1600" dirty="0"/>
              <a:t> </a:t>
            </a:r>
            <a:r>
              <a:rPr lang="pt-PT" sz="1600" dirty="0" err="1"/>
              <a:t>and</a:t>
            </a:r>
            <a:r>
              <a:rPr lang="pt-PT" sz="1600" dirty="0"/>
              <a:t> non-</a:t>
            </a:r>
            <a:r>
              <a:rPr lang="pt-PT" sz="1600" dirty="0" err="1"/>
              <a:t>mycorrhizal</a:t>
            </a:r>
            <a:r>
              <a:rPr lang="pt-PT" sz="1600" dirty="0"/>
              <a:t> </a:t>
            </a:r>
            <a:r>
              <a:rPr lang="pt-PT" sz="1600" dirty="0" err="1"/>
              <a:t>cork</a:t>
            </a:r>
            <a:r>
              <a:rPr lang="pt-PT" sz="1600" dirty="0"/>
              <a:t> </a:t>
            </a:r>
            <a:r>
              <a:rPr lang="pt-PT" sz="1600" dirty="0" err="1"/>
              <a:t>oak</a:t>
            </a:r>
            <a:r>
              <a:rPr lang="pt-PT" sz="1600" dirty="0"/>
              <a:t> </a:t>
            </a:r>
            <a:r>
              <a:rPr lang="pt-PT" sz="1600" dirty="0" err="1"/>
              <a:t>plants</a:t>
            </a:r>
            <a:r>
              <a:rPr lang="pt-PT" sz="1600" dirty="0"/>
              <a:t>. </a:t>
            </a:r>
            <a:r>
              <a:rPr lang="pt-PT" sz="1600" dirty="0" err="1"/>
              <a:t>Values</a:t>
            </a:r>
            <a:r>
              <a:rPr lang="pt-PT" sz="1600" dirty="0"/>
              <a:t> are </a:t>
            </a:r>
            <a:r>
              <a:rPr lang="pt-PT" sz="1600" dirty="0" err="1"/>
              <a:t>the</a:t>
            </a:r>
            <a:r>
              <a:rPr lang="pt-PT" sz="1600" dirty="0"/>
              <a:t> </a:t>
            </a:r>
            <a:r>
              <a:rPr lang="pt-PT" sz="1600" dirty="0" err="1"/>
              <a:t>means</a:t>
            </a:r>
            <a:r>
              <a:rPr lang="pt-PT" sz="1600" dirty="0"/>
              <a:t> </a:t>
            </a:r>
            <a:r>
              <a:rPr lang="pt-PT" sz="1600" dirty="0" err="1"/>
              <a:t>of</a:t>
            </a:r>
            <a:r>
              <a:rPr lang="pt-PT" sz="1600" dirty="0"/>
              <a:t> 3 </a:t>
            </a:r>
            <a:r>
              <a:rPr lang="pt-PT" sz="1600" dirty="0" err="1"/>
              <a:t>replicates</a:t>
            </a:r>
            <a:r>
              <a:rPr lang="pt-PT" sz="1600" dirty="0"/>
              <a:t>. Error </a:t>
            </a:r>
            <a:r>
              <a:rPr lang="pt-PT" sz="1600" dirty="0" err="1"/>
              <a:t>bars</a:t>
            </a:r>
            <a:r>
              <a:rPr lang="pt-PT" sz="1600" dirty="0"/>
              <a:t> </a:t>
            </a:r>
            <a:r>
              <a:rPr lang="pt-PT" sz="1600" dirty="0" err="1"/>
              <a:t>represent</a:t>
            </a:r>
            <a:r>
              <a:rPr lang="pt-PT" sz="1600" dirty="0"/>
              <a:t> standard </a:t>
            </a:r>
            <a:r>
              <a:rPr lang="pt-PT" sz="1600" dirty="0" err="1"/>
              <a:t>deviations</a:t>
            </a:r>
            <a:r>
              <a:rPr lang="pt-PT" sz="1600" dirty="0"/>
              <a:t>. </a:t>
            </a:r>
            <a:r>
              <a:rPr lang="pt-PT" sz="1600" dirty="0" err="1"/>
              <a:t>The</a:t>
            </a:r>
            <a:r>
              <a:rPr lang="pt-PT" sz="1600" dirty="0"/>
              <a:t> </a:t>
            </a:r>
            <a:r>
              <a:rPr lang="pt-PT" sz="1600" dirty="0" err="1"/>
              <a:t>cork</a:t>
            </a:r>
            <a:r>
              <a:rPr lang="pt-PT" sz="1600" dirty="0"/>
              <a:t> </a:t>
            </a:r>
            <a:r>
              <a:rPr lang="pt-PT" sz="1600" dirty="0" err="1"/>
              <a:t>oak</a:t>
            </a:r>
            <a:r>
              <a:rPr lang="pt-PT" sz="1600" dirty="0"/>
              <a:t> </a:t>
            </a:r>
            <a:r>
              <a:rPr lang="pt-PT" sz="1600" dirty="0" err="1"/>
              <a:t>elongation</a:t>
            </a:r>
            <a:r>
              <a:rPr lang="pt-PT" sz="1600" dirty="0"/>
              <a:t> factor-1 </a:t>
            </a:r>
            <a:r>
              <a:rPr lang="pt-PT" sz="1600" dirty="0" err="1"/>
              <a:t>alpha</a:t>
            </a:r>
            <a:r>
              <a:rPr lang="pt-PT" sz="1600" dirty="0"/>
              <a:t> </a:t>
            </a:r>
            <a:r>
              <a:rPr lang="pt-PT" sz="1600" dirty="0" err="1"/>
              <a:t>transcript</a:t>
            </a:r>
            <a:r>
              <a:rPr lang="pt-PT" sz="1600" dirty="0"/>
              <a:t> </a:t>
            </a:r>
            <a:r>
              <a:rPr lang="pt-PT" sz="1600" dirty="0" err="1"/>
              <a:t>was</a:t>
            </a:r>
            <a:r>
              <a:rPr lang="pt-PT" sz="1600" dirty="0"/>
              <a:t> </a:t>
            </a:r>
            <a:r>
              <a:rPr lang="pt-PT" sz="1600" dirty="0" err="1"/>
              <a:t>used</a:t>
            </a:r>
            <a:r>
              <a:rPr lang="pt-PT" sz="1600" dirty="0"/>
              <a:t> as </a:t>
            </a:r>
            <a:r>
              <a:rPr lang="pt-PT" sz="1600" dirty="0" err="1"/>
              <a:t>reference</a:t>
            </a:r>
            <a:r>
              <a:rPr lang="pt-PT" sz="16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59376287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57</Words>
  <Application>Microsoft Office PowerPoint</Application>
  <PresentationFormat>Ecrã Panorâmico</PresentationFormat>
  <Paragraphs>6</Paragraphs>
  <Slides>1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Filipa Sebastiana Vaz Gonçalves</dc:creator>
  <cp:lastModifiedBy>Mónica Guita Sebastiana</cp:lastModifiedBy>
  <cp:revision>2</cp:revision>
  <dcterms:created xsi:type="dcterms:W3CDTF">2021-11-22T20:56:16Z</dcterms:created>
  <dcterms:modified xsi:type="dcterms:W3CDTF">2022-10-04T14:54:36Z</dcterms:modified>
</cp:coreProperties>
</file>